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BD297C-8263-4CF7-9374-512BC7D0D58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948E9A-2434-4CDC-AF8F-A17EEA6759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64C66D-D7EE-425C-AFAD-0D64B1EBEB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DB7639-EF06-489B-96D2-0CC083C13D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160B5-8F3B-42EA-AB05-AF390DAC1F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284E37-F4CB-42F1-B847-5A99300751D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ED1DF6-6676-45E9-B4E6-A71C310C43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58E1DD-E329-4EFB-BEB7-5EBF67C354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547568-1854-4C0D-8A41-DA91C48CF6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0669A6-B5BF-42BC-AAD6-4DB98BC897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A91FE7-C051-47B8-B4D9-F37FCC444B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5A6505-58F4-4464-AEE6-DA2462908B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AD6F73-7D9A-47F7-A928-AF61F3E7979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2"/>
          <p:cNvGrpSpPr/>
          <p:nvPr/>
        </p:nvGrpSpPr>
        <p:grpSpPr>
          <a:xfrm>
            <a:off x="1295280" y="1447920"/>
            <a:ext cx="6858000" cy="4190760"/>
            <a:chOff x="1295280" y="1447920"/>
            <a:chExt cx="6858000" cy="4190760"/>
          </a:xfrm>
        </p:grpSpPr>
        <p:sp>
          <p:nvSpPr>
            <p:cNvPr id="42" name="Rectangle 1"/>
            <p:cNvSpPr/>
            <p:nvPr/>
          </p:nvSpPr>
          <p:spPr>
            <a:xfrm>
              <a:off x="1295280" y="1447920"/>
              <a:ext cx="3436920" cy="9903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~86,000 individuals, aged 40-79 years, enrolled in SCCS, 2002-2009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Rectangle 2"/>
            <p:cNvSpPr/>
            <p:nvPr/>
          </p:nvSpPr>
          <p:spPr>
            <a:xfrm>
              <a:off x="1301400" y="3002040"/>
              <a:ext cx="3422520" cy="11268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,108 SCCS participants with a history of AKI </a:t>
              </a:r>
              <a:r>
                <a:rPr b="0" lang="en-US" sz="1400" spc="-1" strike="noStrike" u="sng">
                  <a:solidFill>
                    <a:srgbClr val="000000"/>
                  </a:solidFill>
                  <a:uFillTx/>
                  <a:latin typeface="Arial"/>
                </a:rPr>
                <a:t>prior to cohort enrollment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were identified by linking the SCCS with Centers for Medicare and Medicaid Services, 1999-201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Rectangle 3"/>
            <p:cNvSpPr/>
            <p:nvPr/>
          </p:nvSpPr>
          <p:spPr>
            <a:xfrm>
              <a:off x="1309320" y="4740480"/>
              <a:ext cx="3422520" cy="8982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826 AKI survivors with complete data on analgesic use were included in the final analyses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Rectangle 12"/>
            <p:cNvSpPr/>
            <p:nvPr/>
          </p:nvSpPr>
          <p:spPr>
            <a:xfrm>
              <a:off x="5181480" y="3352680"/>
              <a:ext cx="2971800" cy="159516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92 participants were excluded because they had a diagnosis of end-stage renal disease (dialysis or transplant) prior to cohort enrollment, identified by linking the SCCS with US Renal Data System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6" name="Straight Arrow Connector 21"/>
            <p:cNvCxnSpPr/>
            <p:nvPr/>
          </p:nvCxnSpPr>
          <p:spPr>
            <a:xfrm flipV="1">
              <a:off x="2815920" y="4377960"/>
              <a:ext cx="2348640" cy="216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</p:grpSp>
      <p:cxnSp>
        <p:nvCxnSpPr>
          <p:cNvPr id="47" name="Straight Arrow Connector 10"/>
          <p:cNvCxnSpPr/>
          <p:nvPr/>
        </p:nvCxnSpPr>
        <p:spPr>
          <a:xfrm>
            <a:off x="2833200" y="2439720"/>
            <a:ext cx="1080" cy="54180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48" name="Straight Arrow Connector 13"/>
          <p:cNvCxnSpPr/>
          <p:nvPr/>
        </p:nvCxnSpPr>
        <p:spPr>
          <a:xfrm>
            <a:off x="2833200" y="4128840"/>
            <a:ext cx="1080" cy="611640"/>
          </a:xfrm>
          <a:prstGeom prst="straightConnector1">
            <a:avLst/>
          </a:prstGeom>
          <a:ln w="2556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29T14:40:38Z</dcterms:created>
  <dc:creator>Kiage, James N</dc:creator>
  <dc:description/>
  <dc:language>en-US</dc:language>
  <cp:lastModifiedBy>Lipworth-Elliot, Loren</cp:lastModifiedBy>
  <dcterms:modified xsi:type="dcterms:W3CDTF">2016-08-22T18:18:16Z</dcterms:modified>
  <cp:revision>16</cp:revision>
  <dc:subject/>
  <dc:title>PowerPoint Presentation</dc:title>
</cp:coreProperties>
</file>